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85" r:id="rId2"/>
  </p:sldIdLst>
  <p:sldSz cx="6264275" cy="8423275"/>
  <p:notesSz cx="6858000" cy="9144000"/>
  <p:defaultTextStyle>
    <a:defPPr>
      <a:defRPr lang="ja-JP"/>
    </a:defPPr>
    <a:lvl1pPr marL="0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1pPr>
    <a:lvl2pPr marL="400553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2pPr>
    <a:lvl3pPr marL="801106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3pPr>
    <a:lvl4pPr marL="1201659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4pPr>
    <a:lvl5pPr marL="1602212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5pPr>
    <a:lvl6pPr marL="2002765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6pPr>
    <a:lvl7pPr marL="2403318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7pPr>
    <a:lvl8pPr marL="2803870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8pPr>
    <a:lvl9pPr marL="3204423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680" userDrawn="1">
          <p15:clr>
            <a:srgbClr val="A4A3A4"/>
          </p15:clr>
        </p15:guide>
        <p15:guide id="3" pos="37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45"/>
    <p:restoredTop sz="97843"/>
  </p:normalViewPr>
  <p:slideViewPr>
    <p:cSldViewPr snapToGrid="0" snapToObjects="1">
      <p:cViewPr varScale="1">
        <p:scale>
          <a:sx n="61" d="100"/>
          <a:sy n="61" d="100"/>
        </p:scale>
        <p:origin x="2244" y="72"/>
      </p:cViewPr>
      <p:guideLst>
        <p:guide orient="horz" pos="2653"/>
        <p:guide pos="680"/>
        <p:guide pos="37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araayaka%201\Desktop\200816%20LDH%20killing\200816LDHkill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350440711955409"/>
          <c:y val="6.0791844813740635E-2"/>
          <c:w val="0.68712587642283651"/>
          <c:h val="0.616214105564573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0816-3k'!$M$59:$M$60</c:f>
                <c:numCache>
                  <c:formatCode>General</c:formatCode>
                  <c:ptCount val="2"/>
                  <c:pt idx="0">
                    <c:v>0.76007425019161667</c:v>
                  </c:pt>
                  <c:pt idx="1">
                    <c:v>1.1369705863462951</c:v>
                  </c:pt>
                </c:numCache>
              </c:numRef>
            </c:plus>
            <c:minus>
              <c:numRef>
                <c:f>'200816-3k'!$M$59:$M$60</c:f>
                <c:numCache>
                  <c:formatCode>General</c:formatCode>
                  <c:ptCount val="2"/>
                  <c:pt idx="0">
                    <c:v>0.76007425019161667</c:v>
                  </c:pt>
                  <c:pt idx="1">
                    <c:v>1.13697058634629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0816-3k'!$K$59:$K$60</c:f>
              <c:strCache>
                <c:ptCount val="2"/>
                <c:pt idx="0">
                  <c:v>RA</c:v>
                </c:pt>
                <c:pt idx="1">
                  <c:v>RA+α-GalCer</c:v>
                </c:pt>
              </c:strCache>
            </c:strRef>
          </c:cat>
          <c:val>
            <c:numRef>
              <c:f>'200816-3k'!$L$59:$L$60</c:f>
              <c:numCache>
                <c:formatCode>General</c:formatCode>
                <c:ptCount val="2"/>
                <c:pt idx="0">
                  <c:v>16.107394123327545</c:v>
                </c:pt>
                <c:pt idx="1">
                  <c:v>18.1632771982984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CD7-1D45-8020-6477AB32DD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40"/>
        <c:axId val="-1020491680"/>
        <c:axId val="-1020488960"/>
      </c:barChart>
      <c:catAx>
        <c:axId val="-1020491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defRPr>
            </a:pPr>
            <a:endParaRPr lang="en-US"/>
          </a:p>
        </c:txPr>
        <c:crossAx val="-1020488960"/>
        <c:crosses val="autoZero"/>
        <c:auto val="1"/>
        <c:lblAlgn val="ctr"/>
        <c:lblOffset val="100"/>
        <c:noMultiLvlLbl val="0"/>
      </c:catAx>
      <c:valAx>
        <c:axId val="-1020488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defRPr>
            </a:pPr>
            <a:endParaRPr lang="en-US"/>
          </a:p>
        </c:txPr>
        <c:crossAx val="-1020491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xmlns="" id="{4F6E3F23-4719-CF4D-80C6-29EBAF93514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51C65176-7798-D04B-889F-A17E7CAB7A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E82D50-34A4-8046-9141-8C23055A460B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37F4D3E0-6E5B-E043-822E-8F2029676A4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639DEA74-467C-F14A-AF8A-824DED3D3BB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3186CB-319D-BE40-8B2C-B947F0EE41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10360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E73BF4-12E7-9542-B97B-F014DE3E041F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1143000"/>
            <a:ext cx="22923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6F1AA3-7A58-9648-A642-1F6F057D2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858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1pPr>
    <a:lvl2pPr marL="400553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2pPr>
    <a:lvl3pPr marL="801106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3pPr>
    <a:lvl4pPr marL="1201659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4pPr>
    <a:lvl5pPr marL="1602212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5pPr>
    <a:lvl6pPr marL="2002765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6pPr>
    <a:lvl7pPr marL="2403318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7pPr>
    <a:lvl8pPr marL="2803870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8pPr>
    <a:lvl9pPr marL="3204423" algn="l" defTabSz="801106" rtl="0" eaLnBrk="1" latinLnBrk="0" hangingPunct="1">
      <a:defRPr kumimoji="1" sz="105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ig.1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6F1AA3-7A58-9648-A642-1F6F057D2CB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09883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469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610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934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307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9690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09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134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198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094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635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390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63927-6A94-8841-9202-98DCF7EEA866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E0A9E-4459-A64A-A3CA-20863E7915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0866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D0B2FA49-687F-F845-858D-796DF7A0BE0B}"/>
              </a:ext>
            </a:extLst>
          </p:cNvPr>
          <p:cNvSpPr/>
          <p:nvPr/>
        </p:nvSpPr>
        <p:spPr>
          <a:xfrm>
            <a:off x="1509237" y="669119"/>
            <a:ext cx="5934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o.29</a:t>
            </a: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321D7FBD-9086-F545-8FB2-244CF8EE57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6934441"/>
              </p:ext>
            </p:extLst>
          </p:nvPr>
        </p:nvGraphicFramePr>
        <p:xfrm>
          <a:off x="873237" y="827108"/>
          <a:ext cx="2024565" cy="2443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00CB9061-B6A8-5C4C-8D5E-8DDD3929C419}"/>
              </a:ext>
            </a:extLst>
          </p:cNvPr>
          <p:cNvSpPr/>
          <p:nvPr/>
        </p:nvSpPr>
        <p:spPr>
          <a:xfrm>
            <a:off x="702266" y="635821"/>
            <a:ext cx="401421" cy="34359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50" dirty="0">
                <a:solidFill>
                  <a:schemeClr val="tx1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" panose="020B0604020202020204" pitchFamily="34" charset="0"/>
              </a:rPr>
              <a:t>(</a:t>
            </a:r>
            <a:r>
              <a:rPr lang="ja-JP" altLang="en-US" sz="850">
                <a:solidFill>
                  <a:schemeClr val="tx1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" panose="020B0604020202020204" pitchFamily="34" charset="0"/>
              </a:rPr>
              <a:t>％</a:t>
            </a:r>
            <a:r>
              <a:rPr lang="en-US" altLang="ja-JP" sz="850" dirty="0">
                <a:solidFill>
                  <a:schemeClr val="tx1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" panose="020B0604020202020204" pitchFamily="34" charset="0"/>
              </a:rPr>
              <a:t>)</a:t>
            </a:r>
            <a:endParaRPr lang="ja-JP" altLang="en-US" sz="850" dirty="0">
              <a:solidFill>
                <a:schemeClr val="tx1"/>
              </a:solidFill>
              <a:latin typeface="Arial Unicode MS" panose="020B0604020202020204" pitchFamily="34" charset="-128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A2E1F76-E287-2F4B-84EE-18523C59046C}"/>
              </a:ext>
            </a:extLst>
          </p:cNvPr>
          <p:cNvSpPr txBox="1"/>
          <p:nvPr/>
        </p:nvSpPr>
        <p:spPr>
          <a:xfrm rot="16200000">
            <a:off x="368791" y="1544265"/>
            <a:ext cx="778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Cytotoxicity</a:t>
            </a:r>
            <a:endParaRPr lang="ja-JP" altLang="en-US" sz="900">
              <a:latin typeface="Arial Unicode MS" panose="020B0604020202020204" pitchFamily="34" charset="-128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xmlns="" id="{D6CFC52A-0EB6-5F40-B078-B80ED788A44D}"/>
              </a:ext>
            </a:extLst>
          </p:cNvPr>
          <p:cNvSpPr/>
          <p:nvPr/>
        </p:nvSpPr>
        <p:spPr>
          <a:xfrm>
            <a:off x="294969" y="3270314"/>
            <a:ext cx="5742038" cy="15115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Fig. 1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a. RA-differentiated cells from CD1d-negative patient glioblastoma stem-like cells were pulsed overnight with α-</a:t>
            </a:r>
            <a:r>
              <a:rPr lang="en-US" altLang="ja-JP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GalCer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 (200 ng/ml) and co-cultured with resting </a:t>
            </a:r>
            <a:r>
              <a:rPr lang="en-US" altLang="ja-JP" sz="1200" dirty="0" err="1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iNKT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 cells for 4 h at a 10:1 ratio, and the cytotoxicity was assessed by measuring LDH release. Error bars represent the SEM (</a:t>
            </a:r>
            <a:r>
              <a:rPr lang="en-US" altLang="ja-JP" sz="1200" i="1" dirty="0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ＭＳ Ｐゴシック" panose="020B0600070205080204" pitchFamily="34" charset="-128"/>
              </a:rPr>
              <a:t> = 4).</a:t>
            </a:r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2190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92</TotalTime>
  <Words>64</Words>
  <Application>Microsoft Office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Arial Unicode MS</vt:lpstr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那須 亮</dc:creator>
  <cp:lastModifiedBy>Raja R</cp:lastModifiedBy>
  <cp:revision>386</cp:revision>
  <cp:lastPrinted>2018-12-04T18:42:46Z</cp:lastPrinted>
  <dcterms:created xsi:type="dcterms:W3CDTF">2018-09-25T11:21:30Z</dcterms:created>
  <dcterms:modified xsi:type="dcterms:W3CDTF">2020-10-20T03:04:56Z</dcterms:modified>
</cp:coreProperties>
</file>